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8.jpeg" ContentType="image/jpeg"/>
  <Override PartName="/ppt/media/image10.jpeg" ContentType="image/jpeg"/>
  <Override PartName="/ppt/media/image6.jpeg" ContentType="image/jpeg"/>
  <Override PartName="/ppt/media/image7.jpeg" ContentType="image/jpeg"/>
  <Override PartName="/ppt/media/image1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115236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EB989E-9E8F-4DB8-8346-C6DE59BE1F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461880"/>
            <a:ext cx="6172200" cy="19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688840"/>
            <a:ext cx="617220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6660720"/>
            <a:ext cx="617220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B0E6FA-4198-4B1B-9A1D-0EB0544E1E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461880"/>
            <a:ext cx="6172200" cy="19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688840"/>
            <a:ext cx="301176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688840"/>
            <a:ext cx="301176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6660720"/>
            <a:ext cx="301176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6660720"/>
            <a:ext cx="301176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B743D6-EF8F-490D-B676-8B37B7024A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461880"/>
            <a:ext cx="6172200" cy="19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688840"/>
            <a:ext cx="198720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688840"/>
            <a:ext cx="198720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688840"/>
            <a:ext cx="198720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6660720"/>
            <a:ext cx="198720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6660720"/>
            <a:ext cx="198720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6660720"/>
            <a:ext cx="198720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176F43-B6D2-449F-99B4-042E582C53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461880"/>
            <a:ext cx="6172200" cy="19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688840"/>
            <a:ext cx="6172200" cy="760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182490-A4CA-4A62-BC2C-9AD2787313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461880"/>
            <a:ext cx="6172200" cy="19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688840"/>
            <a:ext cx="6172200" cy="760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7B2D9-A8E9-4AAB-8FEB-590CCCB373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461880"/>
            <a:ext cx="6172200" cy="19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688840"/>
            <a:ext cx="3011760" cy="760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688840"/>
            <a:ext cx="3011760" cy="760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7A4F5C-D268-470A-850A-039FE01EF8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461880"/>
            <a:ext cx="6172200" cy="19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F77730-102C-44F4-A7C5-2F83CB1EEE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461880"/>
            <a:ext cx="6172200" cy="890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3FE9F-5F44-4331-BCBD-EAD8B5708C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461880"/>
            <a:ext cx="6172200" cy="19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688840"/>
            <a:ext cx="301176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688840"/>
            <a:ext cx="3011760" cy="760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6660720"/>
            <a:ext cx="301176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317CE-8FFE-4F1C-B604-0BE873EDAE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461880"/>
            <a:ext cx="6172200" cy="19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688840"/>
            <a:ext cx="3011760" cy="760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688840"/>
            <a:ext cx="301176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6660720"/>
            <a:ext cx="301176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233C57-280D-4C61-83BC-A90CB4EAE1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461880"/>
            <a:ext cx="6172200" cy="19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688840"/>
            <a:ext cx="301176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688840"/>
            <a:ext cx="301176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6660720"/>
            <a:ext cx="6172200" cy="362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B326F4-CED8-4EB9-8D27-81BDB37744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461880"/>
            <a:ext cx="6172200" cy="19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688840"/>
            <a:ext cx="6172200" cy="760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10491840"/>
            <a:ext cx="1600200" cy="79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10491840"/>
            <a:ext cx="2171520" cy="79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10491840"/>
            <a:ext cx="1600200" cy="79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721150-957E-48C4-86F8-B0F20E31FEA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6.jpeg"/><Relationship Id="rId8" Type="http://schemas.openxmlformats.org/officeDocument/2006/relationships/image" Target="../media/image7.jpeg"/><Relationship Id="rId9" Type="http://schemas.openxmlformats.org/officeDocument/2006/relationships/image" Target="../media/image8.jpeg"/><Relationship Id="rId10" Type="http://schemas.openxmlformats.org/officeDocument/2006/relationships/image" Target="../media/image9.jpeg"/><Relationship Id="rId11" Type="http://schemas.openxmlformats.org/officeDocument/2006/relationships/image" Target="../media/image7.jpeg"/><Relationship Id="rId12" Type="http://schemas.openxmlformats.org/officeDocument/2006/relationships/image" Target="../media/image8.jpeg"/><Relationship Id="rId13" Type="http://schemas.openxmlformats.org/officeDocument/2006/relationships/image" Target="../media/image6.jpeg"/><Relationship Id="rId14" Type="http://schemas.openxmlformats.org/officeDocument/2006/relationships/image" Target="../media/image10.jpeg"/><Relationship Id="rId15" Type="http://schemas.openxmlformats.org/officeDocument/2006/relationships/image" Target="../media/image11.jpeg"/><Relationship Id="rId16" Type="http://schemas.openxmlformats.org/officeDocument/2006/relationships/image" Target="../media/image12.jpeg"/><Relationship Id="rId17" Type="http://schemas.openxmlformats.org/officeDocument/2006/relationships/image" Target="../media/image13.jpeg"/><Relationship Id="rId18" Type="http://schemas.openxmlformats.org/officeDocument/2006/relationships/image" Target="../media/image14.jpeg"/><Relationship Id="rId19" Type="http://schemas.openxmlformats.org/officeDocument/2006/relationships/image" Target="../media/image15.jpeg"/><Relationship Id="rId20" Type="http://schemas.openxmlformats.org/officeDocument/2006/relationships/image" Target="../media/image16.jpeg"/><Relationship Id="rId21" Type="http://schemas.openxmlformats.org/officeDocument/2006/relationships/image" Target="../media/image17.jpeg"/><Relationship Id="rId2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68520" y="371304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687600" y="553248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687240" y="7132680"/>
            <a:ext cx="32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"/>
          <p:cNvGrpSpPr/>
          <p:nvPr/>
        </p:nvGrpSpPr>
        <p:grpSpPr>
          <a:xfrm>
            <a:off x="1183680" y="121680"/>
            <a:ext cx="4375800" cy="1012320"/>
            <a:chOff x="1183680" y="121680"/>
            <a:chExt cx="4375800" cy="1012320"/>
          </a:xfrm>
        </p:grpSpPr>
        <p:grpSp>
          <p:nvGrpSpPr>
            <p:cNvPr id="45" name=""/>
            <p:cNvGrpSpPr/>
            <p:nvPr/>
          </p:nvGrpSpPr>
          <p:grpSpPr>
            <a:xfrm>
              <a:off x="1183680" y="130680"/>
              <a:ext cx="2053080" cy="1003320"/>
              <a:chOff x="1183680" y="130680"/>
              <a:chExt cx="2053080" cy="1003320"/>
            </a:xfrm>
          </p:grpSpPr>
          <p:sp>
            <p:nvSpPr>
              <p:cNvPr id="46" name=""/>
              <p:cNvSpPr/>
              <p:nvPr/>
            </p:nvSpPr>
            <p:spPr>
              <a:xfrm>
                <a:off x="1183680" y="570960"/>
                <a:ext cx="609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RUNX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1233360" y="674280"/>
                <a:ext cx="555480" cy="459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18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2239560" y="334440"/>
                <a:ext cx="384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h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2752200" y="337680"/>
                <a:ext cx="384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h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2332080" y="325080"/>
                <a:ext cx="712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 flipH="1">
                <a:off x="2268360" y="331200"/>
                <a:ext cx="60480" cy="106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3030480" y="317160"/>
                <a:ext cx="60480" cy="10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2184480" y="130680"/>
                <a:ext cx="1052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hRNA-RUNX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1761480" y="342360"/>
                <a:ext cx="377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tr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5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1733400" y="523440"/>
                <a:ext cx="1425600" cy="293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6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1733400" y="825120"/>
                <a:ext cx="1425600" cy="29340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57" name=""/>
            <p:cNvGrpSpPr/>
            <p:nvPr/>
          </p:nvGrpSpPr>
          <p:grpSpPr>
            <a:xfrm>
              <a:off x="3496680" y="121680"/>
              <a:ext cx="2062800" cy="981720"/>
              <a:chOff x="3496680" y="121680"/>
              <a:chExt cx="2062800" cy="981720"/>
            </a:xfrm>
          </p:grpSpPr>
          <p:sp>
            <p:nvSpPr>
              <p:cNvPr id="58" name=""/>
              <p:cNvSpPr/>
              <p:nvPr/>
            </p:nvSpPr>
            <p:spPr>
              <a:xfrm>
                <a:off x="3507840" y="551160"/>
                <a:ext cx="609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RUNX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3496680" y="839880"/>
                <a:ext cx="596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β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-acti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4581000" y="316080"/>
                <a:ext cx="384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h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5060520" y="312840"/>
                <a:ext cx="384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h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4640400" y="320760"/>
                <a:ext cx="70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 flipH="1">
                <a:off x="4572000" y="325440"/>
                <a:ext cx="60480" cy="98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5357880" y="328680"/>
                <a:ext cx="5868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4507200" y="121680"/>
                <a:ext cx="1052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hRNA-RUNX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4028400" y="324000"/>
                <a:ext cx="377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tr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7" name="" descr=""/>
              <p:cNvPicPr/>
              <p:nvPr/>
            </p:nvPicPr>
            <p:blipFill>
              <a:blip r:embed="rId3"/>
              <a:stretch/>
            </p:blipFill>
            <p:spPr>
              <a:xfrm>
                <a:off x="4046760" y="503280"/>
                <a:ext cx="1412640" cy="295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8" name="" descr=""/>
              <p:cNvPicPr/>
              <p:nvPr/>
            </p:nvPicPr>
            <p:blipFill>
              <a:blip r:embed="rId4"/>
              <a:stretch/>
            </p:blipFill>
            <p:spPr>
              <a:xfrm>
                <a:off x="4046760" y="808200"/>
                <a:ext cx="1412640" cy="29520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69" name=""/>
            <p:cNvSpPr/>
            <p:nvPr/>
          </p:nvSpPr>
          <p:spPr>
            <a:xfrm>
              <a:off x="1438560" y="255600"/>
              <a:ext cx="361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1).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743640" y="255600"/>
              <a:ext cx="361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2).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1" name=""/>
          <p:cNvSpPr/>
          <p:nvPr/>
        </p:nvSpPr>
        <p:spPr>
          <a:xfrm>
            <a:off x="611280" y="30492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2" name=""/>
          <p:cNvGrpSpPr/>
          <p:nvPr/>
        </p:nvGrpSpPr>
        <p:grpSpPr>
          <a:xfrm>
            <a:off x="1371600" y="1417680"/>
            <a:ext cx="4169880" cy="2133720"/>
            <a:chOff x="1371600" y="1417680"/>
            <a:chExt cx="4169880" cy="2133720"/>
          </a:xfrm>
        </p:grpSpPr>
        <p:pic>
          <p:nvPicPr>
            <p:cNvPr id="73" name="" descr=""/>
            <p:cNvPicPr/>
            <p:nvPr/>
          </p:nvPicPr>
          <p:blipFill>
            <a:blip r:embed="rId5"/>
            <a:stretch/>
          </p:blipFill>
          <p:spPr>
            <a:xfrm>
              <a:off x="1371600" y="1417680"/>
              <a:ext cx="3808440" cy="2133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" name=""/>
            <p:cNvSpPr/>
            <p:nvPr/>
          </p:nvSpPr>
          <p:spPr>
            <a:xfrm>
              <a:off x="4468680" y="1560600"/>
              <a:ext cx="587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451040" y="2222640"/>
              <a:ext cx="803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h1-RUNX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449240" y="2784600"/>
              <a:ext cx="803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h2-RUNX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5300640" y="1563840"/>
              <a:ext cx="0" cy="878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rot="5400000">
              <a:off x="4962600" y="2208240"/>
              <a:ext cx="657000" cy="123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5457960" y="1560600"/>
              <a:ext cx="0" cy="1150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rot="5400000">
              <a:off x="5151960" y="2295000"/>
              <a:ext cx="657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170680" y="1559160"/>
              <a:ext cx="12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5170680" y="2452680"/>
              <a:ext cx="12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334120" y="1560600"/>
              <a:ext cx="12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5324400" y="2703600"/>
              <a:ext cx="13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5" name=""/>
          <p:cNvSpPr/>
          <p:nvPr/>
        </p:nvSpPr>
        <p:spPr>
          <a:xfrm>
            <a:off x="611280" y="160020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"/>
          <p:cNvGrpSpPr/>
          <p:nvPr/>
        </p:nvGrpSpPr>
        <p:grpSpPr>
          <a:xfrm>
            <a:off x="1066680" y="3570120"/>
            <a:ext cx="5333760" cy="1778040"/>
            <a:chOff x="1066680" y="3570120"/>
            <a:chExt cx="5333760" cy="1778040"/>
          </a:xfrm>
        </p:grpSpPr>
        <p:grpSp>
          <p:nvGrpSpPr>
            <p:cNvPr id="87" name=""/>
            <p:cNvGrpSpPr/>
            <p:nvPr/>
          </p:nvGrpSpPr>
          <p:grpSpPr>
            <a:xfrm>
              <a:off x="4830840" y="3570120"/>
              <a:ext cx="1569600" cy="1778040"/>
              <a:chOff x="4830840" y="3570120"/>
              <a:chExt cx="1569600" cy="1778040"/>
            </a:xfrm>
          </p:grpSpPr>
          <p:sp>
            <p:nvSpPr>
              <p:cNvPr id="88" name=""/>
              <p:cNvSpPr/>
              <p:nvPr/>
            </p:nvSpPr>
            <p:spPr>
              <a:xfrm>
                <a:off x="5533920" y="4635360"/>
                <a:ext cx="269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8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5817960" y="4757400"/>
                <a:ext cx="3574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8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*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90" name="" descr=""/>
              <p:cNvPicPr/>
              <p:nvPr/>
            </p:nvPicPr>
            <p:blipFill>
              <a:blip r:embed="rId6"/>
              <a:stretch/>
            </p:blipFill>
            <p:spPr>
              <a:xfrm>
                <a:off x="4830840" y="3570120"/>
                <a:ext cx="1569600" cy="1778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1" name=""/>
              <p:cNvSpPr/>
              <p:nvPr/>
            </p:nvSpPr>
            <p:spPr>
              <a:xfrm>
                <a:off x="5531400" y="4579920"/>
                <a:ext cx="240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5799960" y="4674960"/>
                <a:ext cx="3207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4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*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3" name=""/>
            <p:cNvSpPr/>
            <p:nvPr/>
          </p:nvSpPr>
          <p:spPr>
            <a:xfrm>
              <a:off x="5534280" y="463536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5818320" y="4757760"/>
              <a:ext cx="357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5" name="" descr=""/>
            <p:cNvPicPr/>
            <p:nvPr/>
          </p:nvPicPr>
          <p:blipFill>
            <a:blip r:embed="rId7"/>
            <a:stretch/>
          </p:blipFill>
          <p:spPr>
            <a:xfrm>
              <a:off x="4830840" y="3570120"/>
              <a:ext cx="1569600" cy="1778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6" name=""/>
            <p:cNvSpPr/>
            <p:nvPr/>
          </p:nvSpPr>
          <p:spPr>
            <a:xfrm>
              <a:off x="5531760" y="457992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5782320" y="4684680"/>
              <a:ext cx="301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CA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8" name=""/>
            <p:cNvGrpSpPr/>
            <p:nvPr/>
          </p:nvGrpSpPr>
          <p:grpSpPr>
            <a:xfrm>
              <a:off x="1066680" y="3725640"/>
              <a:ext cx="3768120" cy="1285920"/>
              <a:chOff x="1066680" y="3725640"/>
              <a:chExt cx="3768120" cy="1285920"/>
            </a:xfrm>
          </p:grpSpPr>
          <p:pic>
            <p:nvPicPr>
              <p:cNvPr id="99" name="" descr=""/>
              <p:cNvPicPr/>
              <p:nvPr/>
            </p:nvPicPr>
            <p:blipFill>
              <a:blip r:embed="rId8"/>
              <a:stretch/>
            </p:blipFill>
            <p:spPr>
              <a:xfrm>
                <a:off x="2320920" y="3789360"/>
                <a:ext cx="1248480" cy="121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0" name="" descr=""/>
              <p:cNvPicPr/>
              <p:nvPr/>
            </p:nvPicPr>
            <p:blipFill>
              <a:blip r:embed="rId9"/>
              <a:stretch/>
            </p:blipFill>
            <p:spPr>
              <a:xfrm>
                <a:off x="3584880" y="3789360"/>
                <a:ext cx="1249920" cy="121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1" name="" descr=""/>
              <p:cNvPicPr/>
              <p:nvPr/>
            </p:nvPicPr>
            <p:blipFill>
              <a:blip r:embed="rId10"/>
              <a:stretch/>
            </p:blipFill>
            <p:spPr>
              <a:xfrm>
                <a:off x="1066680" y="3794040"/>
                <a:ext cx="1240920" cy="121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2" name="" descr=""/>
              <p:cNvPicPr/>
              <p:nvPr/>
            </p:nvPicPr>
            <p:blipFill>
              <a:blip r:embed="rId11"/>
              <a:stretch/>
            </p:blipFill>
            <p:spPr>
              <a:xfrm>
                <a:off x="2320920" y="3789360"/>
                <a:ext cx="1248480" cy="121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3" name="" descr=""/>
              <p:cNvPicPr/>
              <p:nvPr/>
            </p:nvPicPr>
            <p:blipFill>
              <a:blip r:embed="rId12"/>
              <a:stretch/>
            </p:blipFill>
            <p:spPr>
              <a:xfrm>
                <a:off x="3584880" y="3789360"/>
                <a:ext cx="1249920" cy="1217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4" name=""/>
              <p:cNvSpPr/>
              <p:nvPr/>
            </p:nvSpPr>
            <p:spPr>
              <a:xfrm>
                <a:off x="1474920" y="3732120"/>
                <a:ext cx="377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tr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2765160" y="3725640"/>
                <a:ext cx="384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h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4038480" y="3725640"/>
                <a:ext cx="384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h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7" name=""/>
            <p:cNvGrpSpPr/>
            <p:nvPr/>
          </p:nvGrpSpPr>
          <p:grpSpPr>
            <a:xfrm>
              <a:off x="4830840" y="3570120"/>
              <a:ext cx="1569600" cy="1778040"/>
              <a:chOff x="4830840" y="3570120"/>
              <a:chExt cx="1569600" cy="1778040"/>
            </a:xfrm>
          </p:grpSpPr>
          <p:sp>
            <p:nvSpPr>
              <p:cNvPr id="108" name=""/>
              <p:cNvSpPr/>
              <p:nvPr/>
            </p:nvSpPr>
            <p:spPr>
              <a:xfrm>
                <a:off x="5533920" y="4635360"/>
                <a:ext cx="269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8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5817960" y="4757760"/>
                <a:ext cx="3574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8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*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10" name="" descr=""/>
              <p:cNvPicPr/>
              <p:nvPr/>
            </p:nvPicPr>
            <p:blipFill>
              <a:blip r:embed="rId13"/>
              <a:stretch/>
            </p:blipFill>
            <p:spPr>
              <a:xfrm>
                <a:off x="4830840" y="3570120"/>
                <a:ext cx="1569600" cy="1778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1" name=""/>
              <p:cNvSpPr/>
              <p:nvPr/>
            </p:nvSpPr>
            <p:spPr>
              <a:xfrm>
                <a:off x="5531400" y="4579920"/>
                <a:ext cx="240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5782320" y="4684680"/>
                <a:ext cx="3013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4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CA" sz="14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13" name=""/>
          <p:cNvGrpSpPr/>
          <p:nvPr/>
        </p:nvGrpSpPr>
        <p:grpSpPr>
          <a:xfrm>
            <a:off x="1009800" y="6894360"/>
            <a:ext cx="5405400" cy="1727280"/>
            <a:chOff x="1009800" y="6894360"/>
            <a:chExt cx="5405400" cy="1727280"/>
          </a:xfrm>
        </p:grpSpPr>
        <p:grpSp>
          <p:nvGrpSpPr>
            <p:cNvPr id="114" name=""/>
            <p:cNvGrpSpPr/>
            <p:nvPr/>
          </p:nvGrpSpPr>
          <p:grpSpPr>
            <a:xfrm>
              <a:off x="4896000" y="6894360"/>
              <a:ext cx="1519200" cy="1727280"/>
              <a:chOff x="4896000" y="6894360"/>
              <a:chExt cx="1519200" cy="1727280"/>
            </a:xfrm>
          </p:grpSpPr>
          <p:pic>
            <p:nvPicPr>
              <p:cNvPr id="115" name="" descr=""/>
              <p:cNvPicPr/>
              <p:nvPr/>
            </p:nvPicPr>
            <p:blipFill>
              <a:blip r:embed="rId14"/>
              <a:stretch/>
            </p:blipFill>
            <p:spPr>
              <a:xfrm>
                <a:off x="4896000" y="6894360"/>
                <a:ext cx="1519200" cy="1727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6" name=""/>
              <p:cNvSpPr/>
              <p:nvPr/>
            </p:nvSpPr>
            <p:spPr>
              <a:xfrm>
                <a:off x="5564160" y="7980480"/>
                <a:ext cx="250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4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5840640" y="7932600"/>
                <a:ext cx="250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4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8" name=""/>
            <p:cNvGrpSpPr/>
            <p:nvPr/>
          </p:nvGrpSpPr>
          <p:grpSpPr>
            <a:xfrm>
              <a:off x="1009800" y="7199280"/>
              <a:ext cx="3892680" cy="1012680"/>
              <a:chOff x="1009800" y="7199280"/>
              <a:chExt cx="3892680" cy="1012680"/>
            </a:xfrm>
          </p:grpSpPr>
          <p:pic>
            <p:nvPicPr>
              <p:cNvPr id="119" name="" descr=""/>
              <p:cNvPicPr/>
              <p:nvPr/>
            </p:nvPicPr>
            <p:blipFill>
              <a:blip r:embed="rId15"/>
              <a:stretch/>
            </p:blipFill>
            <p:spPr>
              <a:xfrm>
                <a:off x="3619800" y="7265880"/>
                <a:ext cx="1282680" cy="946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0" name="" descr=""/>
              <p:cNvPicPr/>
              <p:nvPr/>
            </p:nvPicPr>
            <p:blipFill>
              <a:blip r:embed="rId16"/>
              <a:stretch/>
            </p:blipFill>
            <p:spPr>
              <a:xfrm>
                <a:off x="1009800" y="7261200"/>
                <a:ext cx="1284120" cy="946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1" name="" descr=""/>
              <p:cNvPicPr/>
              <p:nvPr/>
            </p:nvPicPr>
            <p:blipFill>
              <a:blip r:embed="rId17"/>
              <a:stretch/>
            </p:blipFill>
            <p:spPr>
              <a:xfrm>
                <a:off x="2319480" y="7261200"/>
                <a:ext cx="1284120" cy="946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2" name=""/>
              <p:cNvSpPr/>
              <p:nvPr/>
            </p:nvSpPr>
            <p:spPr>
              <a:xfrm>
                <a:off x="1469160" y="7199280"/>
                <a:ext cx="398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tr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2773440" y="7211880"/>
                <a:ext cx="398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h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4097520" y="7202160"/>
                <a:ext cx="398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h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25" name=""/>
          <p:cNvSpPr/>
          <p:nvPr/>
        </p:nvSpPr>
        <p:spPr>
          <a:xfrm>
            <a:off x="142920" y="8799480"/>
            <a:ext cx="6629400" cy="2270160"/>
          </a:xfrm>
          <a:prstGeom prst="rect">
            <a:avLst/>
          </a:prstGeom>
          <a:noFill/>
          <a:ln w="9360">
            <a:solidFill>
              <a:srgbClr val="ffcc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100" spc="-1" strike="noStrike">
                <a:solidFill>
                  <a:srgbClr val="000000"/>
                </a:solidFill>
                <a:latin typeface="Arial"/>
              </a:rPr>
              <a:t>Figure S5</a:t>
            </a:r>
            <a:r>
              <a:rPr b="0" lang="en-CA" sz="11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hRNA-mediated knockdown of the RUNX2 expression in A2780s cells and consecutive analyses of functional phenotypes. A, Semi-quantitative duplex RT-PCR (1) and Western-blot analysis (2) of RUNX2 mRNA and protein expression levels in the shRNA-RUNX2 clones 1 and 2 (sh1 and sh2), compared to the mock-transfected control clone. The 18S ribosomal RNA gene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actin were used as internal standard, respectively. B, </a:t>
            </a:r>
            <a:r>
              <a:rPr b="0" lang="en-CA" sz="1100" spc="-1" strike="noStrike">
                <a:solidFill>
                  <a:srgbClr val="000000"/>
                </a:solidFill>
                <a:latin typeface="Arial"/>
              </a:rPr>
              <a:t>effect of RUNX2 knockdown on cell proliferation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, Representative images of colony formation assays following RUNX2 knockdown (left) and graph bars presentation of colony numbers in the control clone and shRNA-RUNX2 clones sh1, sh2 (right)</a:t>
            </a:r>
            <a:r>
              <a:rPr b="0" lang="en-CA" sz="11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D, E, </a:t>
            </a:r>
            <a:r>
              <a:rPr b="0" lang="en-CA" sz="1100" spc="-1" strike="noStrike">
                <a:solidFill>
                  <a:srgbClr val="000000"/>
                </a:solidFill>
                <a:latin typeface="Arial"/>
              </a:rPr>
              <a:t>Representative images from one of the three independent experiments showing migration (D, left) and invasion (E, left) in the control clone and shRNA-RUNX2 clones sh1 and sh2 (at magnification ×400). The bar graphs in panels D (</a:t>
            </a:r>
            <a:r>
              <a:rPr b="0" i="1" lang="en-CA" sz="1100" spc="-1" strike="noStrike">
                <a:solidFill>
                  <a:srgbClr val="000000"/>
                </a:solidFill>
                <a:latin typeface="Arial"/>
              </a:rPr>
              <a:t>right</a:t>
            </a:r>
            <a:r>
              <a:rPr b="0" lang="en-CA" sz="1100" spc="-1" strike="noStrike">
                <a:solidFill>
                  <a:srgbClr val="000000"/>
                </a:solidFill>
                <a:latin typeface="Arial"/>
              </a:rPr>
              <a:t>) and E (</a:t>
            </a:r>
            <a:r>
              <a:rPr b="0" i="1" lang="en-CA" sz="1100" spc="-1" strike="noStrike">
                <a:solidFill>
                  <a:srgbClr val="000000"/>
                </a:solidFill>
                <a:latin typeface="Arial"/>
              </a:rPr>
              <a:t>right</a:t>
            </a:r>
            <a:r>
              <a:rPr b="0" lang="en-CA" sz="1100" spc="-1" strike="noStrike">
                <a:solidFill>
                  <a:srgbClr val="000000"/>
                </a:solidFill>
                <a:latin typeface="Arial"/>
              </a:rPr>
              <a:t>) are quantitative determinations of data obtained by selecting 10 random fields per filter (at magnification× 40) under phase contrast microscopy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Differences between shRNA-RUNX2-transfected and vehicle-transfected A2780s cells were determined by a Student’s t-test. Error bars denote ± SEM and </a:t>
            </a:r>
            <a:r>
              <a:rPr b="0" lang="en-CA" sz="1100" spc="-1" strike="noStrike">
                <a:solidFill>
                  <a:srgbClr val="000000"/>
                </a:solidFill>
                <a:latin typeface="Arial"/>
              </a:rPr>
              <a:t>*indicates statistical significance (</a:t>
            </a:r>
            <a:r>
              <a:rPr b="0" i="1" lang="en-CA" sz="11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CA" sz="1100" spc="-1" strike="noStrike">
                <a:solidFill>
                  <a:srgbClr val="000000"/>
                </a:solidFill>
                <a:latin typeface="Arial"/>
              </a:rPr>
              <a:t> &lt;  0.05)</a:t>
            </a:r>
            <a:r>
              <a:rPr b="0" lang="fr-CA" sz="11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6" name=""/>
          <p:cNvGrpSpPr/>
          <p:nvPr/>
        </p:nvGrpSpPr>
        <p:grpSpPr>
          <a:xfrm>
            <a:off x="1000080" y="5313240"/>
            <a:ext cx="5405400" cy="1726920"/>
            <a:chOff x="1000080" y="5313240"/>
            <a:chExt cx="5405400" cy="1726920"/>
          </a:xfrm>
        </p:grpSpPr>
        <p:grpSp>
          <p:nvGrpSpPr>
            <p:cNvPr id="127" name=""/>
            <p:cNvGrpSpPr/>
            <p:nvPr/>
          </p:nvGrpSpPr>
          <p:grpSpPr>
            <a:xfrm>
              <a:off x="4886280" y="5313240"/>
              <a:ext cx="1519200" cy="1726920"/>
              <a:chOff x="4886280" y="5313240"/>
              <a:chExt cx="1519200" cy="1726920"/>
            </a:xfrm>
          </p:grpSpPr>
          <p:pic>
            <p:nvPicPr>
              <p:cNvPr id="128" name="" descr=""/>
              <p:cNvPicPr/>
              <p:nvPr/>
            </p:nvPicPr>
            <p:blipFill>
              <a:blip r:embed="rId18"/>
              <a:stretch/>
            </p:blipFill>
            <p:spPr>
              <a:xfrm>
                <a:off x="4886280" y="5313240"/>
                <a:ext cx="1519200" cy="1726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9" name=""/>
              <p:cNvSpPr/>
              <p:nvPr/>
            </p:nvSpPr>
            <p:spPr>
              <a:xfrm>
                <a:off x="5564160" y="6179760"/>
                <a:ext cx="250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4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5835600" y="6294240"/>
                <a:ext cx="250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4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1" name=""/>
            <p:cNvGrpSpPr/>
            <p:nvPr/>
          </p:nvGrpSpPr>
          <p:grpSpPr>
            <a:xfrm>
              <a:off x="1000080" y="5617800"/>
              <a:ext cx="3892680" cy="997200"/>
              <a:chOff x="1000080" y="5617800"/>
              <a:chExt cx="3892680" cy="997200"/>
            </a:xfrm>
          </p:grpSpPr>
          <p:pic>
            <p:nvPicPr>
              <p:cNvPr id="132" name="" descr=""/>
              <p:cNvPicPr/>
              <p:nvPr/>
            </p:nvPicPr>
            <p:blipFill>
              <a:blip r:embed="rId19"/>
              <a:stretch/>
            </p:blipFill>
            <p:spPr>
              <a:xfrm>
                <a:off x="3610080" y="5665680"/>
                <a:ext cx="1282680" cy="944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33" name="" descr=""/>
              <p:cNvPicPr/>
              <p:nvPr/>
            </p:nvPicPr>
            <p:blipFill>
              <a:blip r:embed="rId20"/>
              <a:stretch/>
            </p:blipFill>
            <p:spPr>
              <a:xfrm>
                <a:off x="1000080" y="5670360"/>
                <a:ext cx="1284480" cy="944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34" name="" descr=""/>
              <p:cNvPicPr/>
              <p:nvPr/>
            </p:nvPicPr>
            <p:blipFill>
              <a:blip r:embed="rId21"/>
              <a:stretch/>
            </p:blipFill>
            <p:spPr>
              <a:xfrm>
                <a:off x="2309760" y="5670360"/>
                <a:ext cx="1284480" cy="944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35" name=""/>
              <p:cNvSpPr/>
              <p:nvPr/>
            </p:nvSpPr>
            <p:spPr>
              <a:xfrm>
                <a:off x="1383120" y="5617800"/>
                <a:ext cx="398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tr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2678040" y="5617800"/>
                <a:ext cx="398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h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4049640" y="5636880"/>
                <a:ext cx="398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h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07T21:34:42Z</dcterms:created>
  <dc:creator>dbatch</dc:creator>
  <dc:description/>
  <dc:language>en-US</dc:language>
  <cp:lastModifiedBy>Dbatch</cp:lastModifiedBy>
  <dcterms:modified xsi:type="dcterms:W3CDTF">2013-09-10T16:31:51Z</dcterms:modified>
  <cp:revision>49</cp:revision>
  <dc:subject/>
  <dc:title>Diapositive 1</dc:title>
</cp:coreProperties>
</file>